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3" r:id="rId4"/>
    <p:sldId id="264" r:id="rId5"/>
    <p:sldId id="260" r:id="rId6"/>
    <p:sldId id="266" r:id="rId7"/>
    <p:sldId id="265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05" d="100"/>
          <a:sy n="105" d="100"/>
        </p:scale>
        <p:origin x="798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0934492-65A6-4852-ABB6-51A55978294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89330C23-C206-40B8-88E1-EEAC95BE80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E5C2ADE-2444-496B-B49C-C3E1F09B54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3B3D-7DFF-417D-A72F-77CEE158AB00}" type="datetimeFigureOut">
              <a:rPr lang="zh-CN" altLang="en-US" smtClean="0"/>
              <a:t>2026/7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F42FC32-1141-4276-A5D2-690FAA832B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C3B99E7-2834-4124-95B3-FF354847F5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DF80-65B9-49EE-A09D-6FE422DC41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374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C8DBA72-1082-47C7-86B1-161BED7A22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9EA9AEC-EC78-4D0C-860D-8BCACBBBB3A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474C635-1229-4383-A97D-D4726220A3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3B3D-7DFF-417D-A72F-77CEE158AB00}" type="datetimeFigureOut">
              <a:rPr lang="zh-CN" altLang="en-US" smtClean="0"/>
              <a:t>2026/7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CA4AC47-CA5F-4DC2-9132-8C3EBDE565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8AF3669-3DBB-4025-A26A-335D06C326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DF80-65B9-49EE-A09D-6FE422DC41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999855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583E76F-39F4-4E3D-BAE5-A840CA36D49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A964BAE-7BF6-45C9-A365-147B7DD288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081EFB7-0B60-4FA8-B841-817F289E7B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3B3D-7DFF-417D-A72F-77CEE158AB00}" type="datetimeFigureOut">
              <a:rPr lang="zh-CN" altLang="en-US" smtClean="0"/>
              <a:t>2026/7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2FB7EEE-E4BE-4B45-8DCA-02C4122B49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321C57C-FAE9-42B1-9254-63E160CC0E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DF80-65B9-49EE-A09D-6FE422DC41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67419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BAD2E1-4DB6-4B9B-9F4B-8484233111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212CEB6-5CB3-429D-8D64-7CB3B801F6D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EECABB1-8AE3-4EF1-9E96-149E8B49C1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3B3D-7DFF-417D-A72F-77CEE158AB00}" type="datetimeFigureOut">
              <a:rPr lang="zh-CN" altLang="en-US" smtClean="0"/>
              <a:t>2026/7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0E1B02A-AC37-4E63-9712-C6B90D917E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56EDAE7-9D0D-4174-BEC3-866D48C8D1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DF80-65B9-49EE-A09D-6FE422DC41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21743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60C497F-CBDB-484C-A421-7A3CADA4BE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BE737AB-D748-407F-9241-B01FFBBAF2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607EF8F-3B90-47EB-9CB8-4C385E2808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3B3D-7DFF-417D-A72F-77CEE158AB00}" type="datetimeFigureOut">
              <a:rPr lang="zh-CN" altLang="en-US" smtClean="0"/>
              <a:t>2026/7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E9E0EED-395E-4BD1-A4F7-5BE6864939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603E5C0-7E03-4DA7-828E-7BB8A6F613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DF80-65B9-49EE-A09D-6FE422DC41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912280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5AE952E-4692-4740-8BFF-2B864452AE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B02AE52-76B6-4F3E-A930-548D327AE04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2D690B2-E882-4CC3-B0CE-0D94D3E77F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205E3AB-676A-463C-98E3-8B2C741639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3B3D-7DFF-417D-A72F-77CEE158AB00}" type="datetimeFigureOut">
              <a:rPr lang="zh-CN" altLang="en-US" smtClean="0"/>
              <a:t>2026/7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B9C7652-5794-4C46-9D9F-4344843626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E80F491-86A9-4687-B914-516EFD6731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DF80-65B9-49EE-A09D-6FE422DC41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50539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594F4A0-93B3-4EFB-864B-F17ABCB5DC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1562B07-59D7-44BF-A19B-560C564949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45EB4DC-71FF-47AB-8EF6-C141BB534C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33CDF40-62D7-416C-87B6-94664431181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89AAB1F-550E-4374-B85C-17C4B4C048A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D8A3FC9-FD5A-483E-8BDB-468D74F38A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3B3D-7DFF-417D-A72F-77CEE158AB00}" type="datetimeFigureOut">
              <a:rPr lang="zh-CN" altLang="en-US" smtClean="0"/>
              <a:t>2026/7/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816AC48C-A519-45A2-B156-42A40AB95B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B81762F-B6ED-49EF-94E5-90EC87D72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DF80-65B9-49EE-A09D-6FE422DC41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97483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A0DF471-FCD2-4D7C-BA20-8F31672435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8CF7626-29AE-4B54-AA25-00F3F50934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3B3D-7DFF-417D-A72F-77CEE158AB00}" type="datetimeFigureOut">
              <a:rPr lang="zh-CN" altLang="en-US" smtClean="0"/>
              <a:t>2026/7/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99192FE-5F29-48AE-8213-324CF1733B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D874FF0-6F29-49B8-A02A-4AA4FD258F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DF80-65B9-49EE-A09D-6FE422DC41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66651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7C4842A-9FDC-4E4E-A6A7-22E7FB610B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3B3D-7DFF-417D-A72F-77CEE158AB00}" type="datetimeFigureOut">
              <a:rPr lang="zh-CN" altLang="en-US" smtClean="0"/>
              <a:t>2026/7/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11C2C35-388C-40C7-A89F-5E76961AA6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C6C94DA-2572-4B19-85B1-80FB6EA201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DF80-65B9-49EE-A09D-6FE422DC41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79622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88CE180-5CFF-4E21-9F6D-A5D4A6B652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4129BD2-8D23-4957-934E-C0F04C86DB2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C5AA332-BF72-4449-AD9C-2EE32CE0E9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638A890-9A90-4D6E-B2C0-38A4349C4A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3B3D-7DFF-417D-A72F-77CEE158AB00}" type="datetimeFigureOut">
              <a:rPr lang="zh-CN" altLang="en-US" smtClean="0"/>
              <a:t>2026/7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8BB368A-399D-4DCF-B4A8-76A1097F8E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17A4CC2-C413-4C54-825B-28CD28C97B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DF80-65B9-49EE-A09D-6FE422DC41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24403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7D0D4BB-AC69-4C04-A39B-7647FFFB58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2A31E0C-B378-44E8-88EA-F71682FF2CC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F42C068-62A8-4A7D-B064-7144C93158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47F519A-AE9D-43D5-93E0-9A0DCAE34D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3B3D-7DFF-417D-A72F-77CEE158AB00}" type="datetimeFigureOut">
              <a:rPr lang="zh-CN" altLang="en-US" smtClean="0"/>
              <a:t>2026/7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7800A41-9EFB-48C3-A3BD-3136931578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9BD10F0-FE10-4977-9D80-2275ECE4A2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DF80-65B9-49EE-A09D-6FE422DC41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78804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58056A3D-F6D5-4ECC-85A4-1044D05895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62159B0-9318-4CCA-8DEE-6A94AF5AC3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0F1518F-8642-45B9-AAE3-B8F2F310F7A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B23B3D-7DFF-417D-A72F-77CEE158AB00}" type="datetimeFigureOut">
              <a:rPr lang="zh-CN" altLang="en-US" smtClean="0"/>
              <a:t>2026/7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BE0A779-C600-421A-A359-E38764ECA03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F5DB4DE-8299-4001-9D65-CAF4856F13B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2FDF80-65B9-49EE-A09D-6FE422DC41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81182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png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1.png"/><Relationship Id="rId5" Type="http://schemas.openxmlformats.org/officeDocument/2006/relationships/image" Target="../media/image30.png"/><Relationship Id="rId4" Type="http://schemas.openxmlformats.org/officeDocument/2006/relationships/image" Target="../media/image2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EEA14313-DE6A-4959-8BD2-E71ABB507740}"/>
              </a:ext>
            </a:extLst>
          </p:cNvPr>
          <p:cNvSpPr txBox="1"/>
          <p:nvPr/>
        </p:nvSpPr>
        <p:spPr>
          <a:xfrm>
            <a:off x="4368107" y="6289977"/>
            <a:ext cx="37517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 Transcriptome boxplot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5920" y="1674641"/>
            <a:ext cx="11109457" cy="37975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619952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EEA14313-DE6A-4959-8BD2-E71ABB507740}"/>
              </a:ext>
            </a:extLst>
          </p:cNvPr>
          <p:cNvSpPr txBox="1"/>
          <p:nvPr/>
        </p:nvSpPr>
        <p:spPr>
          <a:xfrm>
            <a:off x="8272966" y="6298425"/>
            <a:ext cx="32210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 DEG Volcano plots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464002" y="1969949"/>
            <a:ext cx="183896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0d_10_vs_TS1d_10</a:t>
            </a: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1972" y="135012"/>
            <a:ext cx="2503026" cy="1834937"/>
          </a:xfrm>
          <a:prstGeom prst="rect">
            <a:avLst/>
          </a:prstGeom>
        </p:spPr>
      </p:pic>
      <p:sp>
        <p:nvSpPr>
          <p:cNvPr id="7" name="矩形 6"/>
          <p:cNvSpPr/>
          <p:nvPr/>
        </p:nvSpPr>
        <p:spPr>
          <a:xfrm>
            <a:off x="4580847" y="1969947"/>
            <a:ext cx="183896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0d_10_vs_TS7d_10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8697692" y="1940192"/>
            <a:ext cx="192873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0d_10_vs_TS14d_10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矩形 8"/>
          <p:cNvSpPr/>
          <p:nvPr/>
        </p:nvSpPr>
        <p:spPr>
          <a:xfrm>
            <a:off x="464002" y="5375841"/>
            <a:ext cx="192873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0d_10_vs_TS21d_10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矩形 9"/>
          <p:cNvSpPr/>
          <p:nvPr/>
        </p:nvSpPr>
        <p:spPr>
          <a:xfrm>
            <a:off x="4535962" y="5375840"/>
            <a:ext cx="192873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0d_10_vs_TS28d_10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44726" y="135012"/>
            <a:ext cx="2511204" cy="1851664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609865" y="135012"/>
            <a:ext cx="2464648" cy="180518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1972" y="3536378"/>
            <a:ext cx="2503026" cy="1839462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44726" y="3536378"/>
            <a:ext cx="2502067" cy="18403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342931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EEA14313-DE6A-4959-8BD2-E71ABB507740}"/>
              </a:ext>
            </a:extLst>
          </p:cNvPr>
          <p:cNvSpPr txBox="1"/>
          <p:nvPr/>
        </p:nvSpPr>
        <p:spPr>
          <a:xfrm>
            <a:off x="8697692" y="6365930"/>
            <a:ext cx="3048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 DEG Volcano plots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464002" y="1969949"/>
            <a:ext cx="183896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0d_1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_vs_TS1d_1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4580847" y="1969947"/>
            <a:ext cx="183896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0d_15_vs_TS7d_15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8697692" y="1940192"/>
            <a:ext cx="192873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0d_15_vs_TS14d_15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矩形 8"/>
          <p:cNvSpPr/>
          <p:nvPr/>
        </p:nvSpPr>
        <p:spPr>
          <a:xfrm>
            <a:off x="464002" y="5375841"/>
            <a:ext cx="192873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0d_15_vs_TS21d_15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矩形 9"/>
          <p:cNvSpPr/>
          <p:nvPr/>
        </p:nvSpPr>
        <p:spPr>
          <a:xfrm>
            <a:off x="4535962" y="5375840"/>
            <a:ext cx="192873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0d_15_vs_TS28d_15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2083" y="107526"/>
            <a:ext cx="2532021" cy="1862421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35317" y="107526"/>
            <a:ext cx="2530022" cy="1862421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697692" y="107525"/>
            <a:ext cx="2533142" cy="1862421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2083" y="3517565"/>
            <a:ext cx="2532021" cy="1859111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58685" y="3517565"/>
            <a:ext cx="2506654" cy="18582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945089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EEA14313-DE6A-4959-8BD2-E71ABB507740}"/>
              </a:ext>
            </a:extLst>
          </p:cNvPr>
          <p:cNvSpPr txBox="1"/>
          <p:nvPr/>
        </p:nvSpPr>
        <p:spPr>
          <a:xfrm>
            <a:off x="8697692" y="6365930"/>
            <a:ext cx="3048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 DEG Volcano plots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464002" y="1969949"/>
            <a:ext cx="202491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0d_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K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_vs_TS1d_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K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4580847" y="1969947"/>
            <a:ext cx="190949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0d_CK_vs_TS7d_10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8697692" y="1940192"/>
            <a:ext cx="206979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0d_CK_vs_TS14d_CK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矩形 8"/>
          <p:cNvSpPr/>
          <p:nvPr/>
        </p:nvSpPr>
        <p:spPr>
          <a:xfrm>
            <a:off x="464002" y="5375841"/>
            <a:ext cx="206979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0d_CK_vs_TS21d_CK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矩形 9"/>
          <p:cNvSpPr/>
          <p:nvPr/>
        </p:nvSpPr>
        <p:spPr>
          <a:xfrm>
            <a:off x="4535962" y="5375840"/>
            <a:ext cx="206979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0d_CK_vs_TS28d_CK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6626" y="93391"/>
            <a:ext cx="2539606" cy="1876556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97219" y="93391"/>
            <a:ext cx="2558653" cy="1876556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530724" y="93391"/>
            <a:ext cx="2549463" cy="1876556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6626" y="3514089"/>
            <a:ext cx="2539606" cy="1861752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97219" y="3514089"/>
            <a:ext cx="2527109" cy="18617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328477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EEA14313-DE6A-4959-8BD2-E71ABB507740}"/>
              </a:ext>
            </a:extLst>
          </p:cNvPr>
          <p:cNvSpPr txBox="1"/>
          <p:nvPr/>
        </p:nvSpPr>
        <p:spPr>
          <a:xfrm>
            <a:off x="8860536" y="6341382"/>
            <a:ext cx="32169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 DEG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eatmap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s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59787" y="2620462"/>
            <a:ext cx="183896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0d_10_vs_TS1d_10</a:t>
            </a: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391" y="79780"/>
            <a:ext cx="2193756" cy="2479313"/>
          </a:xfrm>
          <a:prstGeom prst="rect">
            <a:avLst/>
          </a:prstGeom>
        </p:spPr>
      </p:pic>
      <p:sp>
        <p:nvSpPr>
          <p:cNvPr id="6" name="矩形 5"/>
          <p:cNvSpPr/>
          <p:nvPr/>
        </p:nvSpPr>
        <p:spPr>
          <a:xfrm>
            <a:off x="4984187" y="2620461"/>
            <a:ext cx="183896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0d_10_vs_TS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_10</a:t>
            </a:r>
          </a:p>
        </p:txBody>
      </p:sp>
      <p:sp>
        <p:nvSpPr>
          <p:cNvPr id="7" name="矩形 6"/>
          <p:cNvSpPr/>
          <p:nvPr/>
        </p:nvSpPr>
        <p:spPr>
          <a:xfrm>
            <a:off x="9708587" y="2620461"/>
            <a:ext cx="192873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0d_10_vs_TS1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_10</a:t>
            </a:r>
          </a:p>
        </p:txBody>
      </p:sp>
      <p:sp>
        <p:nvSpPr>
          <p:cNvPr id="8" name="矩形 7"/>
          <p:cNvSpPr/>
          <p:nvPr/>
        </p:nvSpPr>
        <p:spPr>
          <a:xfrm>
            <a:off x="259787" y="5792222"/>
            <a:ext cx="192873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0d_10_vs_TS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1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_10</a:t>
            </a:r>
          </a:p>
        </p:txBody>
      </p:sp>
      <p:sp>
        <p:nvSpPr>
          <p:cNvPr id="9" name="矩形 8"/>
          <p:cNvSpPr/>
          <p:nvPr/>
        </p:nvSpPr>
        <p:spPr>
          <a:xfrm>
            <a:off x="4939302" y="5792222"/>
            <a:ext cx="192873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0d_10_vs_TS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8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_10</a:t>
            </a: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41884" y="79780"/>
            <a:ext cx="2201196" cy="2479313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582533" y="79779"/>
            <a:ext cx="2191807" cy="2479313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2391" y="3327215"/>
            <a:ext cx="2193755" cy="2465007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41883" y="3390033"/>
            <a:ext cx="2126151" cy="24021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686037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EEA14313-DE6A-4959-8BD2-E71ABB507740}"/>
              </a:ext>
            </a:extLst>
          </p:cNvPr>
          <p:cNvSpPr txBox="1"/>
          <p:nvPr/>
        </p:nvSpPr>
        <p:spPr>
          <a:xfrm>
            <a:off x="8869680" y="6341382"/>
            <a:ext cx="32077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 DEG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eatmap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s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59787" y="2620462"/>
            <a:ext cx="183896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0d_1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_vs_TS1d_1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4984187" y="2620461"/>
            <a:ext cx="183896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0d_1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_vs_TS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_1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9708587" y="2620461"/>
            <a:ext cx="192873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0d_1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_vs_TS1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_1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259787" y="5792222"/>
            <a:ext cx="192873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0d_1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_vs_TS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1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_1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矩形 8"/>
          <p:cNvSpPr/>
          <p:nvPr/>
        </p:nvSpPr>
        <p:spPr>
          <a:xfrm>
            <a:off x="4939302" y="5792222"/>
            <a:ext cx="192873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0d_1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_vs_TS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8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_1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0332" y="61629"/>
            <a:ext cx="2267097" cy="2558832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92148" y="61629"/>
            <a:ext cx="2296700" cy="2564004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273567" y="61629"/>
            <a:ext cx="2294514" cy="2566325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0331" y="3245667"/>
            <a:ext cx="2267097" cy="2546555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92148" y="2999733"/>
            <a:ext cx="2497130" cy="27924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8093260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EEA14313-DE6A-4959-8BD2-E71ABB507740}"/>
              </a:ext>
            </a:extLst>
          </p:cNvPr>
          <p:cNvSpPr txBox="1"/>
          <p:nvPr/>
        </p:nvSpPr>
        <p:spPr>
          <a:xfrm>
            <a:off x="8759952" y="6341382"/>
            <a:ext cx="33174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 DEG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eatmap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s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59787" y="2620462"/>
            <a:ext cx="202491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0d_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K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_vs_TS1d_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K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4984187" y="2620461"/>
            <a:ext cx="202491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0d_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K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_vs_TS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_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K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9708587" y="2620461"/>
            <a:ext cx="206979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0d_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K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_vs_TS1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_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K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259787" y="5792222"/>
            <a:ext cx="206979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0d_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K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_vs_TS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1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_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K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矩形 8"/>
          <p:cNvSpPr/>
          <p:nvPr/>
        </p:nvSpPr>
        <p:spPr>
          <a:xfrm>
            <a:off x="4939302" y="5792222"/>
            <a:ext cx="206979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0d_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K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_vs_TS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8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_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K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930" y="49584"/>
            <a:ext cx="2262653" cy="2530690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98925" y="53659"/>
            <a:ext cx="2266469" cy="2566802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457474" y="49584"/>
            <a:ext cx="2256445" cy="253069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929" y="2981764"/>
            <a:ext cx="2510573" cy="2810458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98925" y="2981764"/>
            <a:ext cx="2499674" cy="28034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21904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9</TotalTime>
  <Words>457</Words>
  <Application>Microsoft Office PowerPoint</Application>
  <PresentationFormat>Widescreen</PresentationFormat>
  <Paragraphs>37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等线</vt:lpstr>
      <vt:lpstr>等线 Light</vt:lpstr>
      <vt:lpstr>Arial</vt:lpstr>
      <vt:lpstr>Times New Roman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炜 郭</dc:creator>
  <cp:lastModifiedBy>MDPI</cp:lastModifiedBy>
  <cp:revision>34</cp:revision>
  <dcterms:created xsi:type="dcterms:W3CDTF">2026-05-13T07:00:19Z</dcterms:created>
  <dcterms:modified xsi:type="dcterms:W3CDTF">2026-07-02T07:03:09Z</dcterms:modified>
</cp:coreProperties>
</file>